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6" r:id="rId3"/>
    <p:sldId id="263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21" autoAdjust="0"/>
    <p:restoredTop sz="94660"/>
  </p:normalViewPr>
  <p:slideViewPr>
    <p:cSldViewPr snapToGrid="0">
      <p:cViewPr varScale="1">
        <p:scale>
          <a:sx n="38" d="100"/>
          <a:sy n="38" d="100"/>
        </p:scale>
        <p:origin x="52" y="4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真木 晋太郎" userId="c473ccade7c14590" providerId="LiveId" clId="{E9581309-3570-424B-95D7-AD45B24B8743}"/>
    <pc:docChg chg="addSld modSld">
      <pc:chgData name="真木 晋太郎" userId="c473ccade7c14590" providerId="LiveId" clId="{E9581309-3570-424B-95D7-AD45B24B8743}" dt="2023-04-12T08:15:13.033" v="0"/>
      <pc:docMkLst>
        <pc:docMk/>
      </pc:docMkLst>
      <pc:sldChg chg="add">
        <pc:chgData name="真木 晋太郎" userId="c473ccade7c14590" providerId="LiveId" clId="{E9581309-3570-424B-95D7-AD45B24B8743}" dt="2023-04-12T08:15:13.033" v="0"/>
        <pc:sldMkLst>
          <pc:docMk/>
          <pc:sldMk cId="1191003183" sldId="263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ABB724-0C9F-8CEF-0ED6-D6B9D6D7B3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BDB4A75-333F-8DB2-5163-C144CD4220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0708DB6-E769-1FFB-144C-5D15F5683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0DE30-02C2-40E9-B3EA-86ACF5275BD0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8AE186-1F03-72F9-3F3E-1046F6FEA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85B456-E0A6-0328-C5EE-640FCA3B5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82E9-09D1-458E-8E7F-320308FF82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3861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D67D4F-29A3-2DB1-99B7-CA937E48AF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B4686FC-EC2A-0542-0621-75000771B2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2508D0-97F1-EB55-9BE6-236EAA8F9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0DE30-02C2-40E9-B3EA-86ACF5275BD0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12F5BD3-6A15-911A-A19B-18180C639A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F196BA-CB65-999D-313E-540C4CB2AA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82E9-09D1-458E-8E7F-320308FF82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6150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E7C5569-2F88-3D88-82F6-5EB0BDA23E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8FA3351-3C03-3A83-1D87-387C5F9C1A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C9890E-CFDE-9870-D7FE-6B5895855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0DE30-02C2-40E9-B3EA-86ACF5275BD0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6092B4-8312-8096-25DE-5C9D2B37B9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C2CE5E-AB65-9B96-E288-5B17FBB8D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82E9-09D1-458E-8E7F-320308FF82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9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F01499-9534-FA1D-178E-308313CA4C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F042277-BA48-9D01-E742-0E0819DB2A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337F15-433C-D0AD-10DE-4A24382C43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0DE30-02C2-40E9-B3EA-86ACF5275BD0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CA76A53-E888-61AE-D082-35E8E26B2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F4A5C30-0526-83E8-7DB9-7AC9C009D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82E9-09D1-458E-8E7F-320308FF82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64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ED340A-3315-7ED9-C7A5-E3F6C42638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60D84A2-1480-BA60-C127-6218DA73CF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F77937A-8C16-2D33-4748-2DBFFA709F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0DE30-02C2-40E9-B3EA-86ACF5275BD0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2F2C26-DF63-8A52-E51D-D4238F832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5318F13-F959-7EFD-2F0C-261B34740F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82E9-09D1-458E-8E7F-320308FF82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6140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456379-79A6-3B27-6E01-F3EB09AA5B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F229680-D6CF-ADFD-8E11-802B43A218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935906B-4888-B5DC-8C0B-1393FEE7F5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43C8721-DEEB-13B7-C4AD-75EFC4822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0DE30-02C2-40E9-B3EA-86ACF5275BD0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9C8FCA8-CF39-79E4-D17B-12FF9F9E7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46952AB-2151-5444-D4FA-7FFA3E71E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82E9-09D1-458E-8E7F-320308FF82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3963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D5DCCC-C6EE-1DA2-14DB-081953924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C1D4BD1-3947-0DE3-CC6E-079B5762D4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E1DED57-4CD8-62FE-2682-6E3A0B499C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A5C2FDB-1B95-6C50-80A2-08985B112C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F0A8CB4-836A-819B-35F8-068BD00AD8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7C95E2A-20D9-14F1-C909-05305FC19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0DE30-02C2-40E9-B3EA-86ACF5275BD0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26CEF51-DA93-E9A4-6418-22F8123426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82887D3-DCF2-94E2-4FB6-4B24B8624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82E9-09D1-458E-8E7F-320308FF82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8888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BDF5B4-F958-A279-21B9-74EB7A1D5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07244EF-FF1C-8F65-646F-416A476C09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0DE30-02C2-40E9-B3EA-86ACF5275BD0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06F301B-5BE5-2369-7349-F9BAC286D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283DF6A-3744-4CFC-D647-97044B8A9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82E9-09D1-458E-8E7F-320308FF82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81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E2F3DA4-C491-258E-693A-054FAC705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0DE30-02C2-40E9-B3EA-86ACF5275BD0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32E2610-5465-F162-95D5-5C5883F49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5C3D111-D57B-B0A1-1483-F660FFCF7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82E9-09D1-458E-8E7F-320308FF82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7430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C2AF14-1965-B269-ED31-CD532FA2EB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AE09F9D-ED3D-F87C-6275-F46AF08947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407E9ED-A33E-F5C6-2501-4CE99C4D70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8E8BA78-FC6A-4CCC-DA1A-21A3958D1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0DE30-02C2-40E9-B3EA-86ACF5275BD0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17BEDDF-BB58-AD14-7D55-0F09667F4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5DC7667-46E4-6B5C-EE87-71037D5244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82E9-09D1-458E-8E7F-320308FF82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914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C5F3A0-90F2-12AA-F151-44769DDDF8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03718B3-FC2F-8A92-F727-6A90215CDA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DAC986E-FC2D-2083-0C4A-4AD216B670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7F09775-01DD-1EF1-8D4F-4676B8AA5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0DE30-02C2-40E9-B3EA-86ACF5275BD0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7F8043-7621-39CF-1802-D06CD2ED5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B4FBE94-C300-B39E-CD33-FF7A4370D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C82E9-09D1-458E-8E7F-320308FF82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3400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3581C1A-2058-5569-C0F4-F899F88B20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DBD09B8-0571-9536-344A-9719EFD031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398EA7D-9E85-0B63-F005-FC95B84552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0DE30-02C2-40E9-B3EA-86ACF5275BD0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1E17882-0D64-EE1F-8BC6-F4F9754EE5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8186F59-78E0-FFA3-0483-BCA08B0A35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9C82E9-09D1-458E-8E7F-320308FF82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0845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>
            <a:extLst>
              <a:ext uri="{FF2B5EF4-FFF2-40B4-BE49-F238E27FC236}">
                <a16:creationId xmlns:a16="http://schemas.microsoft.com/office/drawing/2014/main" id="{8DF96472-CF0F-C5E5-208A-FAE41D9EAE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822" y="522486"/>
            <a:ext cx="4299171" cy="3194214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9D4307BB-CC44-F9B9-9F49-2F2431EAE9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69492" y="495881"/>
            <a:ext cx="4299171" cy="3194214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4DDCED83-7B35-31CF-89F5-27141D93925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061" r="1061"/>
          <a:stretch/>
        </p:blipFill>
        <p:spPr>
          <a:xfrm>
            <a:off x="7888470" y="495881"/>
            <a:ext cx="4299171" cy="3194214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C364B658-9172-38DD-9A04-C83C99E662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6822" y="3636664"/>
            <a:ext cx="4299171" cy="3194214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740ED450-7E92-4831-AED5-1C101932150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27101" y="3591854"/>
            <a:ext cx="4372042" cy="3194214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ECB2B303-1B1E-8455-526F-FB709A6D9DE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-4915" t="-1" r="4915" b="-506"/>
          <a:stretch/>
        </p:blipFill>
        <p:spPr>
          <a:xfrm>
            <a:off x="7780808" y="3632207"/>
            <a:ext cx="4299171" cy="3204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7756AC4-6F35-4DE7-BDC4-C478C2EEC8AD}"/>
              </a:ext>
            </a:extLst>
          </p:cNvPr>
          <p:cNvSpPr txBox="1"/>
          <p:nvPr/>
        </p:nvSpPr>
        <p:spPr>
          <a:xfrm>
            <a:off x="3878667" y="579874"/>
            <a:ext cx="309004" cy="3615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DE0AB77-796B-4D00-AB91-5866DA240E92}"/>
              </a:ext>
            </a:extLst>
          </p:cNvPr>
          <p:cNvSpPr txBox="1"/>
          <p:nvPr/>
        </p:nvSpPr>
        <p:spPr>
          <a:xfrm>
            <a:off x="7749627" y="650994"/>
            <a:ext cx="309004" cy="3615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6BA9DBB-876A-491C-856C-0F1666428DFC}"/>
              </a:ext>
            </a:extLst>
          </p:cNvPr>
          <p:cNvSpPr txBox="1"/>
          <p:nvPr/>
        </p:nvSpPr>
        <p:spPr>
          <a:xfrm>
            <a:off x="11599567" y="650994"/>
            <a:ext cx="309004" cy="3615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6D4EE3C-BA4E-4DCD-8C9D-D803DE48A456}"/>
              </a:ext>
            </a:extLst>
          </p:cNvPr>
          <p:cNvSpPr txBox="1"/>
          <p:nvPr/>
        </p:nvSpPr>
        <p:spPr>
          <a:xfrm>
            <a:off x="11675595" y="3739633"/>
            <a:ext cx="512046" cy="44003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BBDE480-9F8A-40E0-8FFC-DCFA5E097B37}"/>
              </a:ext>
            </a:extLst>
          </p:cNvPr>
          <p:cNvSpPr txBox="1"/>
          <p:nvPr/>
        </p:nvSpPr>
        <p:spPr>
          <a:xfrm>
            <a:off x="7746807" y="3693970"/>
            <a:ext cx="452584" cy="44003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89F964E-168F-471F-B025-11122DB3E91F}"/>
              </a:ext>
            </a:extLst>
          </p:cNvPr>
          <p:cNvSpPr txBox="1"/>
          <p:nvPr/>
        </p:nvSpPr>
        <p:spPr>
          <a:xfrm>
            <a:off x="3890959" y="3570155"/>
            <a:ext cx="452584" cy="44003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E841B3D-EA1D-FC70-E975-57697F1818D6}"/>
              </a:ext>
            </a:extLst>
          </p:cNvPr>
          <p:cNvSpPr txBox="1"/>
          <p:nvPr/>
        </p:nvSpPr>
        <p:spPr>
          <a:xfrm>
            <a:off x="42937" y="180634"/>
            <a:ext cx="17534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dalafil 20mg/day 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B0888CB-68B2-5224-2099-B3318E20E65C}"/>
              </a:ext>
            </a:extLst>
          </p:cNvPr>
          <p:cNvSpPr txBox="1"/>
          <p:nvPr/>
        </p:nvSpPr>
        <p:spPr>
          <a:xfrm>
            <a:off x="131787" y="-17506"/>
            <a:ext cx="7738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Z score for each biometric parameter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21BB9FC6-E1FE-7649-00AA-30460F37F87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61765" y="609118"/>
            <a:ext cx="2463595" cy="131243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0B6B67B-5745-974F-CEC0-4B17B2FC0E64}"/>
              </a:ext>
            </a:extLst>
          </p:cNvPr>
          <p:cNvSpPr txBox="1"/>
          <p:nvPr/>
        </p:nvSpPr>
        <p:spPr>
          <a:xfrm>
            <a:off x="5917796" y="386856"/>
            <a:ext cx="27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/>
              <a:t>*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519572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2612453F-27E8-E472-6F73-D6F732D8234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4321"/>
          <a:stretch/>
        </p:blipFill>
        <p:spPr>
          <a:xfrm>
            <a:off x="46417" y="492006"/>
            <a:ext cx="3775979" cy="3187864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5FD2C387-D5DF-92CE-4B3B-D45D8381E7C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4321"/>
          <a:stretch/>
        </p:blipFill>
        <p:spPr>
          <a:xfrm>
            <a:off x="4042254" y="492006"/>
            <a:ext cx="3775979" cy="3187864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092762E5-0063-07F9-C084-4B1D8DA241F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4321"/>
          <a:stretch/>
        </p:blipFill>
        <p:spPr>
          <a:xfrm>
            <a:off x="8084508" y="492006"/>
            <a:ext cx="3775979" cy="3187864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2DD7053B-670C-0FF9-2E99-F02652B81AD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3949"/>
          <a:stretch/>
        </p:blipFill>
        <p:spPr>
          <a:xfrm>
            <a:off x="0" y="3578154"/>
            <a:ext cx="3792354" cy="3187864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9156288D-1E67-FF48-E868-530B7FF1D5D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13654"/>
          <a:stretch/>
        </p:blipFill>
        <p:spPr>
          <a:xfrm>
            <a:off x="4042254" y="3670136"/>
            <a:ext cx="3898588" cy="3187864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2B103E7D-EB1A-1A51-39F4-A1BD37A6E47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14321"/>
          <a:stretch/>
        </p:blipFill>
        <p:spPr>
          <a:xfrm>
            <a:off x="8212966" y="3679870"/>
            <a:ext cx="3775979" cy="318786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38AC351-D7A5-7418-6A60-8380625614FE}"/>
              </a:ext>
            </a:extLst>
          </p:cNvPr>
          <p:cNvSpPr txBox="1"/>
          <p:nvPr/>
        </p:nvSpPr>
        <p:spPr>
          <a:xfrm>
            <a:off x="131787" y="-17506"/>
            <a:ext cx="7738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 score for each biometric parameter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116FA6A-01F0-2CBD-2E33-1DFE3CAF24FB}"/>
              </a:ext>
            </a:extLst>
          </p:cNvPr>
          <p:cNvSpPr txBox="1"/>
          <p:nvPr/>
        </p:nvSpPr>
        <p:spPr>
          <a:xfrm>
            <a:off x="-1016239" y="187421"/>
            <a:ext cx="38745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dalafil 40mg/day 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88275E76-7C92-3107-2E03-CAAF15BD8D2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98669" y="751937"/>
            <a:ext cx="2594662" cy="138225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7D9E8AD-12B4-AC22-233C-88B162070E0C}"/>
              </a:ext>
            </a:extLst>
          </p:cNvPr>
          <p:cNvSpPr txBox="1"/>
          <p:nvPr/>
        </p:nvSpPr>
        <p:spPr>
          <a:xfrm>
            <a:off x="5432678" y="403764"/>
            <a:ext cx="11177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55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10438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ED2C8DC-87BF-6247-CDC0-8CE9583B969C}"/>
              </a:ext>
            </a:extLst>
          </p:cNvPr>
          <p:cNvSpPr txBox="1"/>
          <p:nvPr/>
        </p:nvSpPr>
        <p:spPr>
          <a:xfrm>
            <a:off x="4225613" y="241303"/>
            <a:ext cx="38745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dalafil 20mg/day 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976D829E-D6D4-6904-5BE8-FA9587C9603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335" r="14007"/>
          <a:stretch/>
        </p:blipFill>
        <p:spPr>
          <a:xfrm>
            <a:off x="2206711" y="570158"/>
            <a:ext cx="3789828" cy="3113436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B3FCC161-BAEC-819E-34AC-607F4223852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335" r="14007"/>
          <a:stretch/>
        </p:blipFill>
        <p:spPr>
          <a:xfrm>
            <a:off x="6205275" y="586679"/>
            <a:ext cx="3789828" cy="311343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88BF12A-F8D5-4E34-A2B6-F90A45C09D0E}"/>
              </a:ext>
            </a:extLst>
          </p:cNvPr>
          <p:cNvSpPr txBox="1"/>
          <p:nvPr/>
        </p:nvSpPr>
        <p:spPr>
          <a:xfrm>
            <a:off x="0" y="0"/>
            <a:ext cx="5663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Doppler assessment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se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5799A0F7-B64A-D2A4-0911-14B277E9CBB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4692" b="2335"/>
          <a:stretch/>
        </p:blipFill>
        <p:spPr>
          <a:xfrm>
            <a:off x="6162901" y="3765832"/>
            <a:ext cx="3874576" cy="3113434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1CB7237F-6AAB-5724-CA0F-D99DC096CD9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4692" b="3131"/>
          <a:stretch/>
        </p:blipFill>
        <p:spPr>
          <a:xfrm>
            <a:off x="2221802" y="3765833"/>
            <a:ext cx="3759647" cy="3088034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C9743B5-E06F-EB31-E478-378B88E3C015}"/>
              </a:ext>
            </a:extLst>
          </p:cNvPr>
          <p:cNvSpPr txBox="1"/>
          <p:nvPr/>
        </p:nvSpPr>
        <p:spPr>
          <a:xfrm>
            <a:off x="4267987" y="3549267"/>
            <a:ext cx="38745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dalafil 40mg/day 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1003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9</Words>
  <Application>Microsoft Office PowerPoint</Application>
  <PresentationFormat>ワイド画面</PresentationFormat>
  <Paragraphs>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真木 晋太郎</dc:creator>
  <cp:lastModifiedBy>真木 晋太郎</cp:lastModifiedBy>
  <cp:revision>2</cp:revision>
  <dcterms:created xsi:type="dcterms:W3CDTF">2023-04-09T15:20:51Z</dcterms:created>
  <dcterms:modified xsi:type="dcterms:W3CDTF">2023-04-12T08:15:50Z</dcterms:modified>
</cp:coreProperties>
</file>